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1" d="100"/>
          <a:sy n="61" d="100"/>
        </p:scale>
        <p:origin x="660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roxanne\Desktop\Review\Database%20&amp;%20poolen\20200604%20Diagram%20blood%20culture%20result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nl-NL" sz="1100">
                <a:latin typeface="Times New Roman" panose="02020603050405020304" pitchFamily="18" charset="0"/>
                <a:cs typeface="Times New Roman" panose="02020603050405020304" pitchFamily="18" charset="0"/>
              </a:rPr>
              <a:t>Blood culture results 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Blad1!$A$2</c:f>
              <c:strCache>
                <c:ptCount val="1"/>
                <c:pt idx="0">
                  <c:v>Gram po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-5400000" spcFirstLastPara="1" vertOverflow="ellipsis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Blad1!$B$1:$H$1</c:f>
              <c:strCache>
                <c:ptCount val="7"/>
                <c:pt idx="0">
                  <c:v>Menif et al. </c:v>
                </c:pt>
                <c:pt idx="1">
                  <c:v>Valoor et al. </c:v>
                </c:pt>
                <c:pt idx="2">
                  <c:v>Khan et al. </c:v>
                </c:pt>
                <c:pt idx="3">
                  <c:v>Ibrahiem et al. </c:v>
                </c:pt>
                <c:pt idx="4">
                  <c:v>Webb et al.</c:v>
                </c:pt>
                <c:pt idx="5">
                  <c:v>Ranjit et al, 2013</c:v>
                </c:pt>
                <c:pt idx="6">
                  <c:v>Ranjit et al, 2014</c:v>
                </c:pt>
              </c:strCache>
            </c:strRef>
          </c:cat>
          <c:val>
            <c:numRef>
              <c:f>Blad1!$B$2:$H$2</c:f>
              <c:numCache>
                <c:formatCode>General</c:formatCode>
                <c:ptCount val="7"/>
                <c:pt idx="0">
                  <c:v>48.1</c:v>
                </c:pt>
                <c:pt idx="1">
                  <c:v>66.7</c:v>
                </c:pt>
                <c:pt idx="2">
                  <c:v>66.7</c:v>
                </c:pt>
                <c:pt idx="3">
                  <c:v>35.1</c:v>
                </c:pt>
                <c:pt idx="4">
                  <c:v>65.599999999999994</c:v>
                </c:pt>
                <c:pt idx="5">
                  <c:v>33.299999999999997</c:v>
                </c:pt>
                <c:pt idx="6">
                  <c:v>25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8BA-4D01-95A2-0DC4AB528949}"/>
            </c:ext>
          </c:extLst>
        </c:ser>
        <c:ser>
          <c:idx val="1"/>
          <c:order val="1"/>
          <c:tx>
            <c:strRef>
              <c:f>Blad1!$A$3</c:f>
              <c:strCache>
                <c:ptCount val="1"/>
                <c:pt idx="0">
                  <c:v>Gram neg 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-5400000" spcFirstLastPara="1" vertOverflow="ellipsis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Blad1!$B$1:$H$1</c:f>
              <c:strCache>
                <c:ptCount val="7"/>
                <c:pt idx="0">
                  <c:v>Menif et al. </c:v>
                </c:pt>
                <c:pt idx="1">
                  <c:v>Valoor et al. </c:v>
                </c:pt>
                <c:pt idx="2">
                  <c:v>Khan et al. </c:v>
                </c:pt>
                <c:pt idx="3">
                  <c:v>Ibrahiem et al. </c:v>
                </c:pt>
                <c:pt idx="4">
                  <c:v>Webb et al.</c:v>
                </c:pt>
                <c:pt idx="5">
                  <c:v>Ranjit et al, 2013</c:v>
                </c:pt>
                <c:pt idx="6">
                  <c:v>Ranjit et al, 2014</c:v>
                </c:pt>
              </c:strCache>
            </c:strRef>
          </c:cat>
          <c:val>
            <c:numRef>
              <c:f>Blad1!$B$3:$H$3</c:f>
              <c:numCache>
                <c:formatCode>General</c:formatCode>
                <c:ptCount val="7"/>
                <c:pt idx="0">
                  <c:v>48.1</c:v>
                </c:pt>
                <c:pt idx="1">
                  <c:v>33.299999999999997</c:v>
                </c:pt>
                <c:pt idx="2">
                  <c:v>22.2</c:v>
                </c:pt>
                <c:pt idx="3">
                  <c:v>64.900000000000006</c:v>
                </c:pt>
                <c:pt idx="4">
                  <c:v>37.5</c:v>
                </c:pt>
                <c:pt idx="5">
                  <c:v>50</c:v>
                </c:pt>
                <c:pt idx="6">
                  <c:v>64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8BA-4D01-95A2-0DC4AB528949}"/>
            </c:ext>
          </c:extLst>
        </c:ser>
        <c:ser>
          <c:idx val="2"/>
          <c:order val="2"/>
          <c:tx>
            <c:strRef>
              <c:f>Blad1!$A$4</c:f>
              <c:strCache>
                <c:ptCount val="1"/>
                <c:pt idx="0">
                  <c:v>Other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-5400000" spcFirstLastPara="1" vertOverflow="ellipsis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Blad1!$B$1:$H$1</c:f>
              <c:strCache>
                <c:ptCount val="7"/>
                <c:pt idx="0">
                  <c:v>Menif et al. </c:v>
                </c:pt>
                <c:pt idx="1">
                  <c:v>Valoor et al. </c:v>
                </c:pt>
                <c:pt idx="2">
                  <c:v>Khan et al. </c:v>
                </c:pt>
                <c:pt idx="3">
                  <c:v>Ibrahiem et al. </c:v>
                </c:pt>
                <c:pt idx="4">
                  <c:v>Webb et al.</c:v>
                </c:pt>
                <c:pt idx="5">
                  <c:v>Ranjit et al, 2013</c:v>
                </c:pt>
                <c:pt idx="6">
                  <c:v>Ranjit et al, 2014</c:v>
                </c:pt>
              </c:strCache>
            </c:strRef>
          </c:cat>
          <c:val>
            <c:numRef>
              <c:f>Blad1!$B$4:$H$4</c:f>
              <c:numCache>
                <c:formatCode>General</c:formatCode>
                <c:ptCount val="7"/>
                <c:pt idx="0">
                  <c:v>3.7</c:v>
                </c:pt>
                <c:pt idx="2">
                  <c:v>11.1</c:v>
                </c:pt>
                <c:pt idx="5">
                  <c:v>16.7</c:v>
                </c:pt>
                <c:pt idx="6">
                  <c:v>3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8BA-4D01-95A2-0DC4AB528949}"/>
            </c:ext>
          </c:extLst>
        </c:ser>
        <c:ser>
          <c:idx val="3"/>
          <c:order val="3"/>
          <c:tx>
            <c:strRef>
              <c:f>Blad1!$A$5</c:f>
              <c:strCache>
                <c:ptCount val="1"/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Blad1!$B$1:$H$1</c:f>
              <c:strCache>
                <c:ptCount val="7"/>
                <c:pt idx="0">
                  <c:v>Menif et al. </c:v>
                </c:pt>
                <c:pt idx="1">
                  <c:v>Valoor et al. </c:v>
                </c:pt>
                <c:pt idx="2">
                  <c:v>Khan et al. </c:v>
                </c:pt>
                <c:pt idx="3">
                  <c:v>Ibrahiem et al. </c:v>
                </c:pt>
                <c:pt idx="4">
                  <c:v>Webb et al.</c:v>
                </c:pt>
                <c:pt idx="5">
                  <c:v>Ranjit et al, 2013</c:v>
                </c:pt>
                <c:pt idx="6">
                  <c:v>Ranjit et al, 2014</c:v>
                </c:pt>
              </c:strCache>
            </c:strRef>
          </c:cat>
          <c:val>
            <c:numRef>
              <c:f>Blad1!$B$5:$H$5</c:f>
              <c:numCache>
                <c:formatCode>General</c:formatCode>
                <c:ptCount val="7"/>
              </c:numCache>
            </c:numRef>
          </c:val>
          <c:extLst>
            <c:ext xmlns:c16="http://schemas.microsoft.com/office/drawing/2014/chart" uri="{C3380CC4-5D6E-409C-BE32-E72D297353CC}">
              <c16:uniqueId val="{00000003-48BA-4D01-95A2-0DC4AB528949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830063407"/>
        <c:axId val="839468239"/>
      </c:barChart>
      <c:catAx>
        <c:axId val="83006340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839468239"/>
        <c:crosses val="autoZero"/>
        <c:auto val="1"/>
        <c:lblAlgn val="ctr"/>
        <c:lblOffset val="100"/>
        <c:noMultiLvlLbl val="0"/>
      </c:catAx>
      <c:valAx>
        <c:axId val="839468239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nl-NL" sz="11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 of positive blood cultur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30063407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3"/>
        <c:delete val="1"/>
      </c:legendEntry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1">
  <a:schemeClr val="accent1"/>
  <a:schemeClr val="accent3"/>
  <a:schemeClr val="accent5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/>
    </cs:fontRef>
    <cs:defRPr sz="1000" kern="1200"/>
  </cs:axisTitle>
  <cs:categoryAxis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9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/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/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/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/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/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/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7A34DF-2FA2-4838-B66F-5FD36642E8C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645C72F-4A4C-4CFA-91F7-EB339D8FF07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43D610-2E37-4932-A94C-0559301A78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C7C5B-6695-433E-BB78-359A83C12C11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E231EC-F086-4A79-9192-2264D48AE1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CA5260-6BB5-41DD-8098-DADB3ED489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9A0AB-9784-448F-9D0C-83B1ED7CC6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42331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8EFE94-213F-4BE7-B8AC-C640EBAC08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A151275-13FD-4B78-BF8E-43BA2FE70A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FFE883-2FDB-47D6-A77B-55D97FE2BF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C7C5B-6695-433E-BB78-359A83C12C11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99FC6C-CE6D-49F4-B138-6E75C467C7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A26017-873E-44E2-A63E-5BC9421E6A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9A0AB-9784-448F-9D0C-83B1ED7CC6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91703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94CC0F3-08F7-491B-823F-CBC491031CA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B89182B-EF8C-416B-90D0-B61C8C4BE4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A3D3A0-1C73-490B-8D18-AD519D4E25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C7C5B-6695-433E-BB78-359A83C12C11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C3CE29-472C-49DC-9A49-7688982586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C95390-175F-4FB8-90D4-6EBCD02684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9A0AB-9784-448F-9D0C-83B1ED7CC6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90035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5F1108-8F0B-4D7A-9B5A-07B2B1FAF9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F03BFEA-17DD-469A-93E1-961FB154027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52C54F-DCD4-4D05-AC91-791BA57DD0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C7C5B-6695-433E-BB78-359A83C12C11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66B8FA-2EE6-401C-BBBF-0A3BED8199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9E194F-88F6-415E-B79E-801286960C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9A0AB-9784-448F-9D0C-83B1ED7CC6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60808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C4D231-4CA1-47BB-9D8B-5469DA11AD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BF06470-1B80-4ACF-9B98-8ECF893EBA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F47AEC-3487-4515-A60D-CDC7D45F03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C7C5B-6695-433E-BB78-359A83C12C11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0EAB28-6DC3-4E08-918C-93C05A7D02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1699FD-CF6C-4695-B3E4-884B533BF3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9A0AB-9784-448F-9D0C-83B1ED7CC6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45090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D0D1F0-AE9A-433F-9B4C-7388E43164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D9DF09E-A78B-40AC-9CEE-1E49618AE92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8523D00-B47E-44DC-98C7-4855BB5E3B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377D248-0DD0-4402-8DA8-FF46D46757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C7C5B-6695-433E-BB78-359A83C12C11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E2A68E1-CD65-440D-8AEC-F83DDBE4C9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98C2E5E-E2BF-4BD7-B964-E852048246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9A0AB-9784-448F-9D0C-83B1ED7CC6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06983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E4C245-3924-4FA1-B775-F3270832C4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E1968C0-A9C4-4B0D-B6DA-DCCDB6005F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3150F74-B40B-4D10-836C-C0AF1C9C80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79C5906-B59E-4D94-8794-1F19617099B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C5A91B0-C83D-4658-88BE-73C152AB35A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E1342F6-8B6B-4947-B996-52969CE066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C7C5B-6695-433E-BB78-359A83C12C11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EC1FF1D-E248-4182-BF33-E1F0BC7F40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4EA6E9F-25F4-4E04-A0DB-A52FAA180C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9A0AB-9784-448F-9D0C-83B1ED7CC6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7340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31F33E-8639-457A-AEE6-6991547C99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CFA3A3E-F5C8-48C3-88A1-A26481D0CF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C7C5B-6695-433E-BB78-359A83C12C11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3001E74-C42B-410A-A573-52B8046D25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219AC6B-1165-4B0B-9DD6-DBB8BE72BD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9A0AB-9784-448F-9D0C-83B1ED7CC6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97024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9594A68-F864-43B0-B88A-D21F8A5FF2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C7C5B-6695-433E-BB78-359A83C12C11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DAE0A23-9264-43A7-8C8A-FECD5400A5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879D9F5-4044-4E66-AA2E-96F5ACC3E7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9A0AB-9784-448F-9D0C-83B1ED7CC6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64009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F7D8BD-3586-4FA8-BA46-7AE33647A3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4FFD422-2461-4076-AF15-6D4780FC252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F3A8B8C-4CD6-445D-B33F-85D23EA67E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B218D34-537F-4EF9-87D1-558A0307AE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C7C5B-6695-433E-BB78-359A83C12C11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B0A3232-3249-400B-BC61-E33F3D0A1C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1BDD22B-6EB5-42E4-AF14-A30457642C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9A0AB-9784-448F-9D0C-83B1ED7CC6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35186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607856-7562-46C3-B1A1-8CFD2AE6AB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19C8B72-CEAE-470D-84D9-E7859209519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B980EF5-3D98-4661-A416-2F44C92AEB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3814038-0194-49F5-ABE6-D55DC005D1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C7C5B-6695-433E-BB78-359A83C12C11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1AB8012-149C-429F-B01F-613C9BC033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98E31BC-7402-4354-B025-A30D2F6E74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9A0AB-9784-448F-9D0C-83B1ED7CC6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62554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B15E523-69F2-494D-9323-076CD32467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702E97A-B6FE-42CD-8A8A-A42F90D915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2B9370-7014-480F-9A9F-FE2F92206B9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3C7C5B-6695-433E-BB78-359A83C12C11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446601-A2D5-427D-BC1F-31477920467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B0AAB6-0ED1-4168-8085-523ABD1055B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19A0AB-9784-448F-9D0C-83B1ED7CC6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46489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5">
            <a:extLst>
              <a:ext uri="{FF2B5EF4-FFF2-40B4-BE49-F238E27FC236}">
                <a16:creationId xmlns:a16="http://schemas.microsoft.com/office/drawing/2014/main" id="{DCE89039-5A1E-4231-8974-0B15DD81559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57450" y="923925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8" name="Grafiek 1">
            <a:extLst>
              <a:ext uri="{FF2B5EF4-FFF2-40B4-BE49-F238E27FC236}">
                <a16:creationId xmlns:a16="http://schemas.microsoft.com/office/drawing/2014/main" id="{F338E7F5-B314-DA40-9300-5B93EA0AB560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364902911"/>
              </p:ext>
            </p:extLst>
          </p:nvPr>
        </p:nvGraphicFramePr>
        <p:xfrm>
          <a:off x="2457450" y="923925"/>
          <a:ext cx="5876925" cy="38531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9" name="Rectangle 6">
            <a:extLst>
              <a:ext uri="{FF2B5EF4-FFF2-40B4-BE49-F238E27FC236}">
                <a16:creationId xmlns:a16="http://schemas.microsoft.com/office/drawing/2014/main" id="{4753DC16-05C6-4C0B-9CE9-5F677D5927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52212" y="4791710"/>
            <a:ext cx="5487400" cy="44627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tabLst>
                <a:tab pos="2635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tabLst>
                <a:tab pos="2635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tabLst>
                <a:tab pos="2635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tabLst>
                <a:tab pos="2635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tabLst>
                <a:tab pos="2635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tabLst>
                <a:tab pos="2635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tabLst>
                <a:tab pos="2635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tabLst>
                <a:tab pos="2635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tabLst>
                <a:tab pos="2635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263525" algn="l"/>
              </a:tabLst>
            </a:pPr>
            <a:r>
              <a:rPr kumimoji="0" lang="en-GB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3: Blood culture results of studies reporting on septic shock (n=7)</a:t>
            </a:r>
            <a:endParaRPr kumimoji="0" lang="en-US" altLang="en-US" sz="11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263525" algn="l"/>
              </a:tabLst>
            </a:pP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	</a:t>
            </a:r>
            <a:endParaRPr kumimoji="0" lang="en-GB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759969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xanne Assies</dc:creator>
  <cp:lastModifiedBy>Roxanne Assies</cp:lastModifiedBy>
  <cp:revision>2</cp:revision>
  <dcterms:created xsi:type="dcterms:W3CDTF">2021-04-04T16:22:04Z</dcterms:created>
  <dcterms:modified xsi:type="dcterms:W3CDTF">2022-05-05T12:14:35Z</dcterms:modified>
</cp:coreProperties>
</file>